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4" d="100"/>
          <a:sy n="54" d="100"/>
        </p:scale>
        <p:origin x="108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22BC96-5697-45C0-AAA7-B9334BF0B8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E279AA-8E88-4948-BAA5-F236717ED9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66D77B-F6DB-4113-82B7-93396FF9F7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EBC8-1F99-4F8E-BFBA-E0C852914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63FDB-5D92-4FA4-8006-3D8964F69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90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4633F-F093-4EA6-9C24-8ECC961624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8DAD58-62B1-4989-881D-53FEE77753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9B902-CB1D-423E-B594-7CC82B2E0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F43DB-848B-43BA-A4E8-15383436D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1C8FF6-BFDA-4B46-9756-22DC84313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05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37FFD1-3847-4AA2-88CC-52D182010F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EF9632-D481-415E-8756-5BC1E89365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A5391-F4AF-44CE-836E-B4148F699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3DE679-767D-411D-8DA6-3674C30AF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C95BF-7E0B-456A-A7A4-0F35C37CD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132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54EE5-7F50-4F8A-A61D-0B682B75D3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F174D3-0C04-4FF8-B021-3F4E0C3C20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31A38F-A374-4EBA-B2F4-880D4C413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C391B4-27EF-4B34-9970-00D67E26E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1E74F5-E9B0-420A-910B-B5258ED8F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01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208CFB-3042-45A7-BE1D-5491E0BA2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1A8BFA-C348-491E-B029-CE160D934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9F1D35-43E0-47A4-AEE3-49387CF23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C4A99-EDDC-46FC-A7D1-70E13D6A3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BBE84-E2C7-43BF-8EE0-F7D13BF34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095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D3B626-D67F-4062-B20E-981AB102F9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BA5CFB-16D1-41E5-943B-AAFB6B0CB6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384C9E-ACC6-49F2-9D52-BDBE81BCF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0DBB84-8215-4C51-939E-444CC729C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E18B05-BF12-43A1-8C4A-328FF5924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580E4E-E4C4-44E5-83F2-EF83B60AF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041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DD426-512F-44B9-885D-264D4DB37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E39165-249F-4CC1-A665-1A3F90AD29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DCB2D6-A0BF-4E34-9379-C53F665C13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6B661A-EBA5-490B-85AA-61A00F54F9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70408D-9024-4DA2-B6B6-112CD7C0EF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D77CAF-E23E-45C2-8F5D-6B9567599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8FC2D7-BED7-4E9E-B77D-DC09B4657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23DBE0-3BAA-4EB6-9012-CCF7569F7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454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458B4-8FD7-4A80-A5A3-3ED3F4291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BC5C4B-658D-4E24-A98E-49B9AD7BC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3AF183-1BDE-4F37-B893-3C1DE0A23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680F46-266B-414E-AEA6-5BFF6005A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905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E4C8BF-E455-442F-8B3F-CC3147E4F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725163-DA35-48F4-8829-57FFACCAE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ACB34F-B1EA-47BA-9B1D-E699BA806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517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1026E-BF9A-4160-BC06-C32DA6EB0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4BCFC-C615-4279-AE43-63AF6BB4D4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C0B8A0-D13A-45D1-AF44-B4CABA352E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FE74A5-F52E-43EE-9E60-CB07C6360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C25EA5-016C-4AF7-A573-DB064D103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95E725-F3FB-4CB7-A8D6-565AD990D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618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5B146C-8271-42F6-A484-2B0C004EDB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7A477F-D803-4552-95DE-4C4EFC5C82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E23CB3-C1B7-43E6-9A92-455E08084B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B6322-F788-4E8D-9CC3-2B0B05AAB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C2F39A-D26D-48C1-908C-0AD191126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25BB64-4742-4AFE-865A-F7B7739AF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57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E871E9-1C5A-4255-BD73-36F8F030C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220FCC-637A-4972-9A3E-680612ACCA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12337-207B-4E1C-A23E-3995C227DA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671D2-E73E-4CBC-B6C8-9F2272330CA3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69844A-99CD-49E7-ACCE-A7F263DE85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B4EB27-9F39-4AB9-8D2C-F9623CB373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768B0-5F54-4F54-925A-4A411912FE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866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09C4630-1BA4-49CA-85F9-7DDD9C66F2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9618587"/>
              </p:ext>
            </p:extLst>
          </p:nvPr>
        </p:nvGraphicFramePr>
        <p:xfrm>
          <a:off x="4079256" y="325391"/>
          <a:ext cx="4570475" cy="6532609"/>
        </p:xfrm>
        <a:graphic>
          <a:graphicData uri="http://schemas.openxmlformats.org/drawingml/2006/table">
            <a:tbl>
              <a:tblPr/>
              <a:tblGrid>
                <a:gridCol w="794570">
                  <a:extLst>
                    <a:ext uri="{9D8B030D-6E8A-4147-A177-3AD203B41FA5}">
                      <a16:colId xmlns:a16="http://schemas.microsoft.com/office/drawing/2014/main" val="1379484610"/>
                    </a:ext>
                  </a:extLst>
                </a:gridCol>
                <a:gridCol w="95077">
                  <a:extLst>
                    <a:ext uri="{9D8B030D-6E8A-4147-A177-3AD203B41FA5}">
                      <a16:colId xmlns:a16="http://schemas.microsoft.com/office/drawing/2014/main" val="2236753077"/>
                    </a:ext>
                  </a:extLst>
                </a:gridCol>
                <a:gridCol w="998305">
                  <a:extLst>
                    <a:ext uri="{9D8B030D-6E8A-4147-A177-3AD203B41FA5}">
                      <a16:colId xmlns:a16="http://schemas.microsoft.com/office/drawing/2014/main" val="4174288936"/>
                    </a:ext>
                  </a:extLst>
                </a:gridCol>
                <a:gridCol w="95077">
                  <a:extLst>
                    <a:ext uri="{9D8B030D-6E8A-4147-A177-3AD203B41FA5}">
                      <a16:colId xmlns:a16="http://schemas.microsoft.com/office/drawing/2014/main" val="1347707909"/>
                    </a:ext>
                  </a:extLst>
                </a:gridCol>
                <a:gridCol w="1358239">
                  <a:extLst>
                    <a:ext uri="{9D8B030D-6E8A-4147-A177-3AD203B41FA5}">
                      <a16:colId xmlns:a16="http://schemas.microsoft.com/office/drawing/2014/main" val="2870965960"/>
                    </a:ext>
                  </a:extLst>
                </a:gridCol>
                <a:gridCol w="95077">
                  <a:extLst>
                    <a:ext uri="{9D8B030D-6E8A-4147-A177-3AD203B41FA5}">
                      <a16:colId xmlns:a16="http://schemas.microsoft.com/office/drawing/2014/main" val="1444468577"/>
                    </a:ext>
                  </a:extLst>
                </a:gridCol>
                <a:gridCol w="1134130">
                  <a:extLst>
                    <a:ext uri="{9D8B030D-6E8A-4147-A177-3AD203B41FA5}">
                      <a16:colId xmlns:a16="http://schemas.microsoft.com/office/drawing/2014/main" val="2915529752"/>
                    </a:ext>
                  </a:extLst>
                </a:gridCol>
              </a:tblGrid>
              <a:tr h="381968">
                <a:tc gridSpan="7"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1. Characteristics of the 30 pre-surgical survival associated proteins and their coefficients in prognosis. 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326953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efficients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 (95% CI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6904712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BP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 (1.8-3.8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0E-0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0611450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A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 (0.19-0.52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0E-0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0992701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NG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 (1.9-9.7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3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9137440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 (1.7-6.5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4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3839030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D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(1.4-3.5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5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3786862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13A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(0.23-0.7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3499035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 (0.3-0.77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592871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HR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 (1.4-5.3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4245407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B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(1.1-1.6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0187469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IH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1.6-9.9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536886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P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 (0.094-0.63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327338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R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 (0.3-0.79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7185804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GBP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(1.3-3.7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987579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A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7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 (0.54-0.89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147996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A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.2-3.2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8541381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IH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7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 (0.22-0.78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879432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A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(1.1-1.4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231765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D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(0.2-0.77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2205930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LYRP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 (0.23-0.81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091776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A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 (1.2-3.1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0129992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CAT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 (0.11-0.75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865403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F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 (0.14-0.78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7506094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I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 (1.2-5.5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7935169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C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(1-1.6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644313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IH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7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 (0.29-0.9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1691364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OLCE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7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 (0.24-0.9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8126183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LD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(0.38-0.94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796389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OL1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4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 (0.3-0.93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8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4982527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G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 (0.22-0.93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2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3424694"/>
                  </a:ext>
                </a:extLst>
              </a:tr>
              <a:tr h="193757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PR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9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 (0.39-0.96)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3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9990766"/>
                  </a:ext>
                </a:extLst>
              </a:tr>
              <a:tr h="144174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: Hazard Ratio; 95%CI: 95% confidence interval</a:t>
                      </a: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39" marR="4939" marT="493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29101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2ACE0AC-204C-45D2-8EE0-3217A34E1722}"/>
              </a:ext>
            </a:extLst>
          </p:cNvPr>
          <p:cNvSpPr txBox="1"/>
          <p:nvPr/>
        </p:nvSpPr>
        <p:spPr>
          <a:xfrm>
            <a:off x="3995351" y="131805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nline only</a:t>
            </a:r>
          </a:p>
        </p:txBody>
      </p:sp>
    </p:spTree>
    <p:extLst>
      <p:ext uri="{BB962C8B-B14F-4D97-AF65-F5344CB8AC3E}">
        <p14:creationId xmlns:p14="http://schemas.microsoft.com/office/powerpoint/2010/main" val="4291298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3025B9E-1CB6-44AD-ACC5-F9AF0B9777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1717831"/>
              </p:ext>
            </p:extLst>
          </p:nvPr>
        </p:nvGraphicFramePr>
        <p:xfrm>
          <a:off x="1937266" y="1841539"/>
          <a:ext cx="8432798" cy="1691640"/>
        </p:xfrm>
        <a:graphic>
          <a:graphicData uri="http://schemas.openxmlformats.org/drawingml/2006/table">
            <a:tbl>
              <a:tblPr/>
              <a:tblGrid>
                <a:gridCol w="948690">
                  <a:extLst>
                    <a:ext uri="{9D8B030D-6E8A-4147-A177-3AD203B41FA5}">
                      <a16:colId xmlns:a16="http://schemas.microsoft.com/office/drawing/2014/main" val="1744536144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4168163628"/>
                    </a:ext>
                  </a:extLst>
                </a:gridCol>
                <a:gridCol w="1255337">
                  <a:extLst>
                    <a:ext uri="{9D8B030D-6E8A-4147-A177-3AD203B41FA5}">
                      <a16:colId xmlns:a16="http://schemas.microsoft.com/office/drawing/2014/main" val="3537808309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255587073"/>
                    </a:ext>
                  </a:extLst>
                </a:gridCol>
                <a:gridCol w="1054100">
                  <a:extLst>
                    <a:ext uri="{9D8B030D-6E8A-4147-A177-3AD203B41FA5}">
                      <a16:colId xmlns:a16="http://schemas.microsoft.com/office/drawing/2014/main" val="3123892962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3630658325"/>
                    </a:ext>
                  </a:extLst>
                </a:gridCol>
                <a:gridCol w="1609898">
                  <a:extLst>
                    <a:ext uri="{9D8B030D-6E8A-4147-A177-3AD203B41FA5}">
                      <a16:colId xmlns:a16="http://schemas.microsoft.com/office/drawing/2014/main" val="1051797360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315103035"/>
                    </a:ext>
                  </a:extLst>
                </a:gridCol>
                <a:gridCol w="1111596">
                  <a:extLst>
                    <a:ext uri="{9D8B030D-6E8A-4147-A177-3AD203B41FA5}">
                      <a16:colId xmlns:a16="http://schemas.microsoft.com/office/drawing/2014/main" val="843989709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730215786"/>
                    </a:ext>
                  </a:extLst>
                </a:gridCol>
                <a:gridCol w="785784">
                  <a:extLst>
                    <a:ext uri="{9D8B030D-6E8A-4147-A177-3AD203B41FA5}">
                      <a16:colId xmlns:a16="http://schemas.microsoft.com/office/drawing/2014/main" val="1700716427"/>
                    </a:ext>
                  </a:extLst>
                </a:gridCol>
                <a:gridCol w="134158">
                  <a:extLst>
                    <a:ext uri="{9D8B030D-6E8A-4147-A177-3AD203B41FA5}">
                      <a16:colId xmlns:a16="http://schemas.microsoft.com/office/drawing/2014/main" val="3432549708"/>
                    </a:ext>
                  </a:extLst>
                </a:gridCol>
                <a:gridCol w="862445">
                  <a:extLst>
                    <a:ext uri="{9D8B030D-6E8A-4147-A177-3AD203B41FA5}">
                      <a16:colId xmlns:a16="http://schemas.microsoft.com/office/drawing/2014/main" val="824514243"/>
                    </a:ext>
                  </a:extLst>
                </a:gridCol>
              </a:tblGrid>
              <a:tr h="198120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2. Multivariable Cox regression analysis with 4 EV proteins for overall survival in the discovery cohort.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4613604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efficient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%CI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 valu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748693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353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257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815-1.3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385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004258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B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779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4.6151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592-3836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3521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4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080676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0848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155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54-0.997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19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65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5650746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A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788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42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83-0.972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01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0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4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7594500"/>
                  </a:ext>
                </a:extLst>
              </a:tr>
              <a:tr h="198120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: Hazard Ratio; 95%CI: 95% confidence interval; SE: The standard error of hazard ratios; z value: Wald z-statistic value.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715871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71DC578-5C11-4E75-82C6-5911EC84EAA1}"/>
              </a:ext>
            </a:extLst>
          </p:cNvPr>
          <p:cNvSpPr txBox="1"/>
          <p:nvPr/>
        </p:nvSpPr>
        <p:spPr>
          <a:xfrm>
            <a:off x="1838412" y="1621119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100" dirty="0"/>
              <a:t>Online only</a:t>
            </a:r>
          </a:p>
        </p:txBody>
      </p:sp>
    </p:spTree>
    <p:extLst>
      <p:ext uri="{BB962C8B-B14F-4D97-AF65-F5344CB8AC3E}">
        <p14:creationId xmlns:p14="http://schemas.microsoft.com/office/powerpoint/2010/main" val="24854632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5DBDD1B-AE45-464B-8CFD-CEFD55FD99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2606599"/>
              </p:ext>
            </p:extLst>
          </p:nvPr>
        </p:nvGraphicFramePr>
        <p:xfrm>
          <a:off x="2742170" y="1042984"/>
          <a:ext cx="6477000" cy="4331843"/>
        </p:xfrm>
        <a:graphic>
          <a:graphicData uri="http://schemas.openxmlformats.org/drawingml/2006/table">
            <a:tbl>
              <a:tblPr/>
              <a:tblGrid>
                <a:gridCol w="1733550">
                  <a:extLst>
                    <a:ext uri="{9D8B030D-6E8A-4147-A177-3AD203B41FA5}">
                      <a16:colId xmlns:a16="http://schemas.microsoft.com/office/drawing/2014/main" val="340235330"/>
                    </a:ext>
                  </a:extLst>
                </a:gridCol>
                <a:gridCol w="1390650">
                  <a:extLst>
                    <a:ext uri="{9D8B030D-6E8A-4147-A177-3AD203B41FA5}">
                      <a16:colId xmlns:a16="http://schemas.microsoft.com/office/drawing/2014/main" val="2716911134"/>
                    </a:ext>
                  </a:extLst>
                </a:gridCol>
                <a:gridCol w="1076325">
                  <a:extLst>
                    <a:ext uri="{9D8B030D-6E8A-4147-A177-3AD203B41FA5}">
                      <a16:colId xmlns:a16="http://schemas.microsoft.com/office/drawing/2014/main" val="414508901"/>
                    </a:ext>
                  </a:extLst>
                </a:gridCol>
                <a:gridCol w="1190625">
                  <a:extLst>
                    <a:ext uri="{9D8B030D-6E8A-4147-A177-3AD203B41FA5}">
                      <a16:colId xmlns:a16="http://schemas.microsoft.com/office/drawing/2014/main" val="2166370318"/>
                    </a:ext>
                  </a:extLst>
                </a:gridCol>
                <a:gridCol w="1085850">
                  <a:extLst>
                    <a:ext uri="{9D8B030D-6E8A-4147-A177-3AD203B41FA5}">
                      <a16:colId xmlns:a16="http://schemas.microsoft.com/office/drawing/2014/main" val="3074724110"/>
                    </a:ext>
                  </a:extLst>
                </a:gridCol>
              </a:tblGrid>
              <a:tr h="198120">
                <a:tc gridSpan="5"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3. Clinical data for all CRLM patients and the number of patients in each stratification group of the risk scor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1664127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risk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risk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953710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01977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=Median (66 years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73 (55.7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87 (46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47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264737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Median (66 years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58 (44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 (54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602743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der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49 (37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61 (32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24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3045549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82 (62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 (67.7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10032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dual disease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 (91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4 (92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8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3707315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1 ( 8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5 ( 7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6367455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therapy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8 (29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48 (31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80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937084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67 (70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 (68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3307593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mor differentiatio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 - G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52 (88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77 (80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0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6463002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3 - G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7 (11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19 (19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7327363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M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A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 (87.0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 (72.0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97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4153585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(13.0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 (28.0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828127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n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5 (42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39 (40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5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552664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dtyp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34 (57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57 (59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5939111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3 ( 6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6 (11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3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6394351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H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44 (93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48 (88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046379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67D1B32-3A09-4599-8A9F-D92CF5965977}"/>
              </a:ext>
            </a:extLst>
          </p:cNvPr>
          <p:cNvSpPr txBox="1"/>
          <p:nvPr/>
        </p:nvSpPr>
        <p:spPr>
          <a:xfrm>
            <a:off x="2643316" y="848497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nline only</a:t>
            </a:r>
          </a:p>
        </p:txBody>
      </p:sp>
    </p:spTree>
    <p:extLst>
      <p:ext uri="{BB962C8B-B14F-4D97-AF65-F5344CB8AC3E}">
        <p14:creationId xmlns:p14="http://schemas.microsoft.com/office/powerpoint/2010/main" val="117143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EDA4D42-372F-42C6-9AFB-72F67B431E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1099739"/>
              </p:ext>
            </p:extLst>
          </p:nvPr>
        </p:nvGraphicFramePr>
        <p:xfrm>
          <a:off x="3016250" y="974095"/>
          <a:ext cx="6159499" cy="4080383"/>
        </p:xfrm>
        <a:graphic>
          <a:graphicData uri="http://schemas.openxmlformats.org/drawingml/2006/table">
            <a:tbl>
              <a:tblPr/>
              <a:tblGrid>
                <a:gridCol w="1973710">
                  <a:extLst>
                    <a:ext uri="{9D8B030D-6E8A-4147-A177-3AD203B41FA5}">
                      <a16:colId xmlns:a16="http://schemas.microsoft.com/office/drawing/2014/main" val="2741918935"/>
                    </a:ext>
                  </a:extLst>
                </a:gridCol>
                <a:gridCol w="724647">
                  <a:extLst>
                    <a:ext uri="{9D8B030D-6E8A-4147-A177-3AD203B41FA5}">
                      <a16:colId xmlns:a16="http://schemas.microsoft.com/office/drawing/2014/main" val="444377280"/>
                    </a:ext>
                  </a:extLst>
                </a:gridCol>
                <a:gridCol w="1153714">
                  <a:extLst>
                    <a:ext uri="{9D8B030D-6E8A-4147-A177-3AD203B41FA5}">
                      <a16:colId xmlns:a16="http://schemas.microsoft.com/office/drawing/2014/main" val="2902680607"/>
                    </a:ext>
                  </a:extLst>
                </a:gridCol>
                <a:gridCol w="1153714">
                  <a:extLst>
                    <a:ext uri="{9D8B030D-6E8A-4147-A177-3AD203B41FA5}">
                      <a16:colId xmlns:a16="http://schemas.microsoft.com/office/drawing/2014/main" val="3664604949"/>
                    </a:ext>
                  </a:extLst>
                </a:gridCol>
                <a:gridCol w="1153714">
                  <a:extLst>
                    <a:ext uri="{9D8B030D-6E8A-4147-A177-3AD203B41FA5}">
                      <a16:colId xmlns:a16="http://schemas.microsoft.com/office/drawing/2014/main" val="732240521"/>
                    </a:ext>
                  </a:extLst>
                </a:gridCol>
              </a:tblGrid>
              <a:tr h="198120">
                <a:tc gridSpan="5"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4. Clinical characteristics of the training and test s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7351767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ning s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st se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9486199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12501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dian follow-up time (days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87812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 (median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3281177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der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111 (34.7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78 (34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33 (34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709176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209 (65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146 (65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63 (65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883049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dual disease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294 (91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211 (94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83 (86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4188134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6 (8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13 (5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13 (13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88589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ent therapy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76 (30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58 (33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18 (24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527110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170 (69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113 (66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57 (76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403432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mor differentiation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-G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129 (83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80 (80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49 (89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492398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3-G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6 (16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0 (20.0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6 (10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5778243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M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A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(78.1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6 (78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 (77.1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1758177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 (21.9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 (21.4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 (22.9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1732475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n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64 (41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44 (41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0 (40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4023072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dtyp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91 (58.7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62 (58.5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9 (59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107107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9 (8.9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4 (5.8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5 (15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810936"/>
                  </a:ext>
                </a:extLst>
              </a:tr>
              <a:tr h="198120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H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92 (91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65 (94.2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27 (84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79805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57BBB62-BBCB-4129-9A1E-3E9AF1A38BA1}"/>
              </a:ext>
            </a:extLst>
          </p:cNvPr>
          <p:cNvSpPr txBox="1"/>
          <p:nvPr/>
        </p:nvSpPr>
        <p:spPr>
          <a:xfrm>
            <a:off x="2924432" y="786627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nline only</a:t>
            </a:r>
          </a:p>
        </p:txBody>
      </p:sp>
    </p:spTree>
    <p:extLst>
      <p:ext uri="{BB962C8B-B14F-4D97-AF65-F5344CB8AC3E}">
        <p14:creationId xmlns:p14="http://schemas.microsoft.com/office/powerpoint/2010/main" val="38539628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43DAD0D-DBD4-4D5A-9E13-1E7E48731F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7807752"/>
              </p:ext>
            </p:extLst>
          </p:nvPr>
        </p:nvGraphicFramePr>
        <p:xfrm>
          <a:off x="1065643" y="795887"/>
          <a:ext cx="10208996" cy="5106380"/>
        </p:xfrm>
        <a:graphic>
          <a:graphicData uri="http://schemas.openxmlformats.org/drawingml/2006/table">
            <a:tbl>
              <a:tblPr/>
              <a:tblGrid>
                <a:gridCol w="1796433">
                  <a:extLst>
                    <a:ext uri="{9D8B030D-6E8A-4147-A177-3AD203B41FA5}">
                      <a16:colId xmlns:a16="http://schemas.microsoft.com/office/drawing/2014/main" val="2486088420"/>
                    </a:ext>
                  </a:extLst>
                </a:gridCol>
                <a:gridCol w="1735092">
                  <a:extLst>
                    <a:ext uri="{9D8B030D-6E8A-4147-A177-3AD203B41FA5}">
                      <a16:colId xmlns:a16="http://schemas.microsoft.com/office/drawing/2014/main" val="3777700992"/>
                    </a:ext>
                  </a:extLst>
                </a:gridCol>
                <a:gridCol w="928887">
                  <a:extLst>
                    <a:ext uri="{9D8B030D-6E8A-4147-A177-3AD203B41FA5}">
                      <a16:colId xmlns:a16="http://schemas.microsoft.com/office/drawing/2014/main" val="72311359"/>
                    </a:ext>
                  </a:extLst>
                </a:gridCol>
                <a:gridCol w="122683">
                  <a:extLst>
                    <a:ext uri="{9D8B030D-6E8A-4147-A177-3AD203B41FA5}">
                      <a16:colId xmlns:a16="http://schemas.microsoft.com/office/drawing/2014/main" val="2692506337"/>
                    </a:ext>
                  </a:extLst>
                </a:gridCol>
                <a:gridCol w="998992">
                  <a:extLst>
                    <a:ext uri="{9D8B030D-6E8A-4147-A177-3AD203B41FA5}">
                      <a16:colId xmlns:a16="http://schemas.microsoft.com/office/drawing/2014/main" val="2797396862"/>
                    </a:ext>
                  </a:extLst>
                </a:gridCol>
                <a:gridCol w="122683">
                  <a:extLst>
                    <a:ext uri="{9D8B030D-6E8A-4147-A177-3AD203B41FA5}">
                      <a16:colId xmlns:a16="http://schemas.microsoft.com/office/drawing/2014/main" val="1600159650"/>
                    </a:ext>
                  </a:extLst>
                </a:gridCol>
                <a:gridCol w="867545">
                  <a:extLst>
                    <a:ext uri="{9D8B030D-6E8A-4147-A177-3AD203B41FA5}">
                      <a16:colId xmlns:a16="http://schemas.microsoft.com/office/drawing/2014/main" val="1716138824"/>
                    </a:ext>
                  </a:extLst>
                </a:gridCol>
                <a:gridCol w="122683">
                  <a:extLst>
                    <a:ext uri="{9D8B030D-6E8A-4147-A177-3AD203B41FA5}">
                      <a16:colId xmlns:a16="http://schemas.microsoft.com/office/drawing/2014/main" val="3110341117"/>
                    </a:ext>
                  </a:extLst>
                </a:gridCol>
                <a:gridCol w="893835">
                  <a:extLst>
                    <a:ext uri="{9D8B030D-6E8A-4147-A177-3AD203B41FA5}">
                      <a16:colId xmlns:a16="http://schemas.microsoft.com/office/drawing/2014/main" val="2292060321"/>
                    </a:ext>
                  </a:extLst>
                </a:gridCol>
                <a:gridCol w="122683">
                  <a:extLst>
                    <a:ext uri="{9D8B030D-6E8A-4147-A177-3AD203B41FA5}">
                      <a16:colId xmlns:a16="http://schemas.microsoft.com/office/drawing/2014/main" val="3786391746"/>
                    </a:ext>
                  </a:extLst>
                </a:gridCol>
                <a:gridCol w="1498488">
                  <a:extLst>
                    <a:ext uri="{9D8B030D-6E8A-4147-A177-3AD203B41FA5}">
                      <a16:colId xmlns:a16="http://schemas.microsoft.com/office/drawing/2014/main" val="3564123422"/>
                    </a:ext>
                  </a:extLst>
                </a:gridCol>
                <a:gridCol w="122683">
                  <a:extLst>
                    <a:ext uri="{9D8B030D-6E8A-4147-A177-3AD203B41FA5}">
                      <a16:colId xmlns:a16="http://schemas.microsoft.com/office/drawing/2014/main" val="3491696395"/>
                    </a:ext>
                  </a:extLst>
                </a:gridCol>
                <a:gridCol w="876309">
                  <a:extLst>
                    <a:ext uri="{9D8B030D-6E8A-4147-A177-3AD203B41FA5}">
                      <a16:colId xmlns:a16="http://schemas.microsoft.com/office/drawing/2014/main" val="3706373214"/>
                    </a:ext>
                  </a:extLst>
                </a:gridCol>
              </a:tblGrid>
              <a:tr h="181597">
                <a:tc gridSpan="13"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5. Univariable and Multivariable Cox Proportional Hazards Regression for CRLM patients in the training set.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263973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ivariable Analysi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lected Factors for Building the Nomogram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68852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efficient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 (95% CI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efficient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 (95% CI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valu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66458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P signatur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risk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484091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risk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 (2.6-6.6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0E-0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9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8 (2.339-6.110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0E-0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806656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P concentration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 Median (54.5 ug/ul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606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Median (54.5 ug/ul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86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 (1.2-2.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90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5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42 (1.154-2.630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1019841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≤ Median (66 years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97372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gt; Median (66 years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 (1.2-2.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5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62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79 (1.176-2.692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0E-03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873995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der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8652066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 (1.2-2.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7892001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idual diseas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5154237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053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 (0.46-2.2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43394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therapy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838660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5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(0.68-1.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4016960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mor differentiation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 - G2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36164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3 - G4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(1.69-4.1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0890217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M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A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611145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B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(1.4-3.3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0E-04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6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28 (1.314-3.129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1E-03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2148788"/>
                  </a:ext>
                </a:extLst>
              </a:tr>
              <a:tr h="174612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RAS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nt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130076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ldtyp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(0.7-2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0509488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L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379443"/>
                  </a:ext>
                </a:extLst>
              </a:tr>
              <a:tr h="181597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I-H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 (0.08-1.7)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076738"/>
                  </a:ext>
                </a:extLst>
              </a:tr>
              <a:tr h="181597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: Hazard Ratio; 95%CI: 95% confidence interval</a:t>
                      </a: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84" marR="6984" marT="698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541911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65C59BA-0449-4C5D-B4C7-0E3318CC9DA0}"/>
              </a:ext>
            </a:extLst>
          </p:cNvPr>
          <p:cNvSpPr txBox="1"/>
          <p:nvPr/>
        </p:nvSpPr>
        <p:spPr>
          <a:xfrm>
            <a:off x="988540" y="609600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nline only</a:t>
            </a:r>
          </a:p>
        </p:txBody>
      </p:sp>
    </p:spTree>
    <p:extLst>
      <p:ext uri="{BB962C8B-B14F-4D97-AF65-F5344CB8AC3E}">
        <p14:creationId xmlns:p14="http://schemas.microsoft.com/office/powerpoint/2010/main" val="19370088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67F3208-7F6D-42B5-9C6F-B7F63C24CC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0594100"/>
              </p:ext>
            </p:extLst>
          </p:nvPr>
        </p:nvGraphicFramePr>
        <p:xfrm>
          <a:off x="2912882" y="754145"/>
          <a:ext cx="7569723" cy="3392672"/>
        </p:xfrm>
        <a:graphic>
          <a:graphicData uri="http://schemas.openxmlformats.org/drawingml/2006/table">
            <a:tbl>
              <a:tblPr/>
              <a:tblGrid>
                <a:gridCol w="2258136">
                  <a:extLst>
                    <a:ext uri="{9D8B030D-6E8A-4147-A177-3AD203B41FA5}">
                      <a16:colId xmlns:a16="http://schemas.microsoft.com/office/drawing/2014/main" val="102219193"/>
                    </a:ext>
                  </a:extLst>
                </a:gridCol>
                <a:gridCol w="3106629">
                  <a:extLst>
                    <a:ext uri="{9D8B030D-6E8A-4147-A177-3AD203B41FA5}">
                      <a16:colId xmlns:a16="http://schemas.microsoft.com/office/drawing/2014/main" val="1461828291"/>
                    </a:ext>
                  </a:extLst>
                </a:gridCol>
                <a:gridCol w="2204958">
                  <a:extLst>
                    <a:ext uri="{9D8B030D-6E8A-4147-A177-3AD203B41FA5}">
                      <a16:colId xmlns:a16="http://schemas.microsoft.com/office/drawing/2014/main" val="254418798"/>
                    </a:ext>
                  </a:extLst>
                </a:gridCol>
              </a:tblGrid>
              <a:tr h="385566">
                <a:tc gridSpan="2">
                  <a:txBody>
                    <a:bodyPr/>
                    <a:lstStyle/>
                    <a:p>
                      <a:pPr marL="0" algn="l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upplementary Table 6. Clinical characteristics of the longitudinal cohort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8142414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Overal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66468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　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1779139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esult after therapy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artial respons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6 (17.1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811539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rogressive diseas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2 (34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82546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table diseas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7 (48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7510613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ge (median [IQR]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64.00 [52.50, 67.50]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6733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Gender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24 (68.6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779735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emal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1 (31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9971631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hemotherapy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OLFIRI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8 (51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1276648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OLFO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7 (48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5377956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Targeted therapy (%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evacizuma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8 (51.4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3101213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etuxima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0 (28.6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001999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endParaRPr lang="zh-CN" altLang="en-US" sz="1100" b="0" i="0" u="none" strike="noStrike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anitumumab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 (5.7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1020411"/>
                  </a:ext>
                </a:extLst>
              </a:tr>
              <a:tr h="197067"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　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10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A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zh-CN" alt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</a:t>
                      </a:r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5 (14.3) 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3786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9869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0</Words>
  <Application>Microsoft Office PowerPoint</Application>
  <PresentationFormat>Breitbild</PresentationFormat>
  <Paragraphs>497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等线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 kuailu</dc:creator>
  <cp:lastModifiedBy>Kahlert, Christoph</cp:lastModifiedBy>
  <cp:revision>8</cp:revision>
  <dcterms:created xsi:type="dcterms:W3CDTF">2020-12-21T16:49:38Z</dcterms:created>
  <dcterms:modified xsi:type="dcterms:W3CDTF">2021-12-22T17:33:10Z</dcterms:modified>
</cp:coreProperties>
</file>